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7" r:id="rId2"/>
  </p:sldIdLst>
  <p:sldSz cx="6858000" cy="9144000" type="screen4x3"/>
  <p:notesSz cx="6802438" cy="9934575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159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7F7F7F"/>
    <a:srgbClr val="646464"/>
    <a:srgbClr val="8282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69" autoAdjust="0"/>
    <p:restoredTop sz="94084" autoAdjust="0"/>
  </p:normalViewPr>
  <p:slideViewPr>
    <p:cSldViewPr snapToGrid="0" snapToObjects="1">
      <p:cViewPr varScale="1">
        <p:scale>
          <a:sx n="87" d="100"/>
          <a:sy n="87" d="100"/>
        </p:scale>
        <p:origin x="648" y="72"/>
      </p:cViewPr>
      <p:guideLst>
        <p:guide orient="horz" pos="2880"/>
        <p:guide pos="2160"/>
        <p:guide orient="horz" pos="159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47343F-9011-4E48-ACD0-AFDBFF8B6C7E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4713" y="1241425"/>
            <a:ext cx="2513012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81014"/>
            <a:ext cx="5441950" cy="39117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F467D0-B869-419D-8DA9-B631581B19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186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873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524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469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64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5562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652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606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3198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747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419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486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ltGray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645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51193" y="367772"/>
            <a:ext cx="1586012" cy="1586012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431710" y="367772"/>
            <a:ext cx="1589365" cy="1586012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551193" y="2200969"/>
            <a:ext cx="1586012" cy="1589365"/>
          </a:xfrm>
          <a:prstGeom prst="rect">
            <a:avLst/>
          </a:prstGeom>
        </p:spPr>
      </p:pic>
      <p:pic>
        <p:nvPicPr>
          <p:cNvPr id="23" name="図 22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2431710" y="2200969"/>
            <a:ext cx="1589365" cy="1589365"/>
          </a:xfrm>
          <a:prstGeom prst="rect">
            <a:avLst/>
          </a:prstGeom>
        </p:spPr>
      </p:pic>
      <p:sp>
        <p:nvSpPr>
          <p:cNvPr id="25" name="テキスト ボックス 24"/>
          <p:cNvSpPr txBox="1"/>
          <p:nvPr/>
        </p:nvSpPr>
        <p:spPr>
          <a:xfrm>
            <a:off x="735855" y="3688022"/>
            <a:ext cx="132119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LR9 expression (ΔMFI) in </a:t>
            </a:r>
            <a:r>
              <a:rPr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pDCs</a:t>
            </a:r>
            <a:endParaRPr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633675" y="3681174"/>
            <a:ext cx="132119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LR9 expression (ΔMFI) in </a:t>
            </a:r>
            <a:r>
              <a:rPr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pDCs</a:t>
            </a:r>
            <a:endParaRPr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08441" y="395866"/>
            <a:ext cx="276999" cy="143182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LR7-mediated IFN-</a:t>
            </a:r>
            <a:r>
              <a:rPr lang="el-GR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ja-JP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(%) in </a:t>
            </a:r>
            <a:r>
              <a:rPr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pDCs</a:t>
            </a:r>
            <a:endParaRPr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08441" y="2234241"/>
            <a:ext cx="276999" cy="143182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LR9-mediated IFN-</a:t>
            </a:r>
            <a:r>
              <a:rPr lang="el-GR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ja-JP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(%) in </a:t>
            </a:r>
            <a:r>
              <a:rPr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pDCs</a:t>
            </a:r>
            <a:endParaRPr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267274" y="196281"/>
            <a:ext cx="373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  <a:endParaRPr lang="ja-JP" alt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087366" y="196281"/>
            <a:ext cx="464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LE</a:t>
            </a:r>
            <a:endParaRPr lang="ja-JP" alt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2302499" y="391850"/>
            <a:ext cx="276999" cy="143182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LR7-mediated IFN-</a:t>
            </a:r>
            <a:r>
              <a:rPr lang="el-GR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ja-JP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(%) in </a:t>
            </a:r>
            <a:r>
              <a:rPr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pDCs</a:t>
            </a:r>
            <a:endParaRPr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289779" y="2234241"/>
            <a:ext cx="276999" cy="143182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LR9-mediated IFN-</a:t>
            </a:r>
            <a:r>
              <a:rPr lang="el-GR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ja-JP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(%) in </a:t>
            </a:r>
            <a:r>
              <a:rPr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pDCs</a:t>
            </a:r>
            <a:endParaRPr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1639821" y="420977"/>
            <a:ext cx="45557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σ</a:t>
            </a:r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 = 0.064</a:t>
            </a:r>
          </a:p>
          <a:p>
            <a:pPr algn="ctr"/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p = 0.765</a:t>
            </a:r>
          </a:p>
          <a:p>
            <a:pPr algn="ctr"/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n = 24</a:t>
            </a:r>
            <a:endParaRPr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466353" y="420977"/>
            <a:ext cx="45557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σ</a:t>
            </a:r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 = 0.164</a:t>
            </a:r>
          </a:p>
          <a:p>
            <a:pPr algn="ctr"/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p = 0.231</a:t>
            </a:r>
          </a:p>
          <a:p>
            <a:pPr algn="ctr"/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n = 55</a:t>
            </a:r>
            <a:endParaRPr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639821" y="2278188"/>
            <a:ext cx="45557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σ</a:t>
            </a:r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 = 0.718</a:t>
            </a:r>
          </a:p>
          <a:p>
            <a:pPr algn="ctr"/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p &lt; 0.001</a:t>
            </a:r>
          </a:p>
          <a:p>
            <a:pPr algn="ctr"/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n = 24</a:t>
            </a:r>
            <a:endParaRPr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3466353" y="2278188"/>
            <a:ext cx="45557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σ</a:t>
            </a:r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 = 0.134</a:t>
            </a:r>
          </a:p>
          <a:p>
            <a:pPr algn="ctr"/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p = 0.329</a:t>
            </a:r>
          </a:p>
          <a:p>
            <a:pPr algn="ctr"/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n = 55</a:t>
            </a:r>
            <a:endParaRPr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740202" y="1854855"/>
            <a:ext cx="132119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LR7 expression (ΔMFI) in </a:t>
            </a:r>
            <a:r>
              <a:rPr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pDCs</a:t>
            </a:r>
            <a:endParaRPr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638022" y="1848007"/>
            <a:ext cx="132119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LR7 expression (ΔMFI) in </a:t>
            </a:r>
            <a:r>
              <a:rPr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pDCs</a:t>
            </a:r>
            <a:endParaRPr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054604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61</TotalTime>
  <Words>94</Words>
  <Application>Microsoft Office PowerPoint</Application>
  <PresentationFormat>画面に合わせる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Symbol</vt:lpstr>
      <vt:lpstr>ホワイト</vt:lpstr>
      <vt:lpstr>PowerPoint プレゼンテーション</vt:lpstr>
    </vt:vector>
  </TitlesOfParts>
  <Company>UOE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WATA SHIGERU</dc:creator>
  <cp:lastModifiedBy>圭 阪田</cp:lastModifiedBy>
  <cp:revision>283</cp:revision>
  <cp:lastPrinted>2017-04-10T01:20:45Z</cp:lastPrinted>
  <dcterms:created xsi:type="dcterms:W3CDTF">2016-08-30T03:40:23Z</dcterms:created>
  <dcterms:modified xsi:type="dcterms:W3CDTF">2018-07-25T02:22:11Z</dcterms:modified>
</cp:coreProperties>
</file>